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4"/>
  </p:sldMasterIdLst>
  <p:notesMasterIdLst>
    <p:notesMasterId r:id="rId6"/>
  </p:notesMasterIdLst>
  <p:sldIdLst>
    <p:sldId id="277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FD5AD25-4E17-2FA4-D475-A9C21A4D8F91}" name="Pieter-Jan De Kam" initials="PK" userId="S::atukprdm@allergytherapeutics.com::54b45d46-5a3c-43b7-a071-0778939a0d8f" providerId="AD"/>
  <p188:author id="{0845EB6C-CEE9-FFE5-0BEC-4CB4D4D72845}" name="Layhadi, Janice A" initials="" userId="S::jal107@ic.ac.uk::0a2e9531-7ec3-43d3-86a3-b0f00bbdd07c" providerId="AD"/>
  <p188:author id="{381C9578-ED66-BE76-5069-BBBE0DD1144D}" name="Sviatlana Starchenka" initials="SS" userId="S::atuksasa@allergytherapeutics.com::27ff1a91-9e63-42ec-9226-e067daa9dc2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9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22"/>
    <p:restoredTop sz="94682"/>
  </p:normalViewPr>
  <p:slideViewPr>
    <p:cSldViewPr snapToGrid="0">
      <p:cViewPr varScale="1">
        <p:scale>
          <a:sx n="82" d="100"/>
          <a:sy n="82" d="100"/>
        </p:scale>
        <p:origin x="32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5333B4-0E67-B747-8AEA-CE4C35533D2C}" type="datetimeFigureOut">
              <a:rPr lang="en-US" smtClean="0"/>
              <a:t>8/2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309145-E194-794F-A12D-6BCF59CB2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316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582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411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211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971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31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04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99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24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97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483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796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8FB87-21F3-594F-832C-EDD7C1525715}" type="datetimeFigureOut">
              <a:rPr lang="en-US" smtClean="0"/>
              <a:t>8/2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62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382326" y="772335"/>
            <a:ext cx="1364226" cy="481822"/>
            <a:chOff x="4916289" y="1026606"/>
            <a:chExt cx="1356440" cy="564102"/>
          </a:xfrm>
        </p:grpSpPr>
        <p:sp>
          <p:nvSpPr>
            <p:cNvPr id="5" name="Rectangle 4"/>
            <p:cNvSpPr/>
            <p:nvPr/>
          </p:nvSpPr>
          <p:spPr>
            <a:xfrm>
              <a:off x="4931764" y="1087422"/>
              <a:ext cx="1340965" cy="503286"/>
            </a:xfrm>
            <a:prstGeom prst="rect">
              <a:avLst/>
            </a:prstGeom>
            <a:noFill/>
            <a:ln w="19050" cap="rnd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5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916289" y="1026606"/>
              <a:ext cx="1325974" cy="518269"/>
            </a:xfrm>
            <a:prstGeom prst="round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/>
                <a:t>Screening</a:t>
              </a:r>
            </a:p>
            <a:p>
              <a:pPr algn="ctr"/>
              <a:r>
                <a:rPr lang="en-US" sz="1000"/>
                <a:t>n=196</a:t>
              </a:r>
            </a:p>
          </p:txBody>
        </p:sp>
      </p:grpSp>
      <p:cxnSp>
        <p:nvCxnSpPr>
          <p:cNvPr id="11" name="Straight Arrow Connector 10"/>
          <p:cNvCxnSpPr>
            <a:cxnSpLocks/>
          </p:cNvCxnSpPr>
          <p:nvPr/>
        </p:nvCxnSpPr>
        <p:spPr>
          <a:xfrm>
            <a:off x="3105384" y="1287912"/>
            <a:ext cx="0" cy="22398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2416480" y="1538123"/>
            <a:ext cx="1348657" cy="745195"/>
            <a:chOff x="5345635" y="1107780"/>
            <a:chExt cx="1475736" cy="759302"/>
          </a:xfrm>
        </p:grpSpPr>
        <p:cxnSp>
          <p:nvCxnSpPr>
            <p:cNvPr id="17" name="Straight Arrow Connector 16"/>
            <p:cNvCxnSpPr/>
            <p:nvPr/>
          </p:nvCxnSpPr>
          <p:spPr>
            <a:xfrm>
              <a:off x="6102849" y="1592762"/>
              <a:ext cx="0" cy="27432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8" name="Group 17"/>
            <p:cNvGrpSpPr/>
            <p:nvPr/>
          </p:nvGrpSpPr>
          <p:grpSpPr>
            <a:xfrm>
              <a:off x="5345635" y="1107780"/>
              <a:ext cx="1475736" cy="443902"/>
              <a:chOff x="4931764" y="1034322"/>
              <a:chExt cx="1349115" cy="636657"/>
            </a:xfrm>
          </p:grpSpPr>
          <p:sp>
            <p:nvSpPr>
              <p:cNvPr id="19" name="Rectangle 18"/>
              <p:cNvSpPr/>
              <p:nvPr/>
            </p:nvSpPr>
            <p:spPr>
              <a:xfrm>
                <a:off x="4931764" y="1034322"/>
                <a:ext cx="1349115" cy="636657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75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946754" y="1052985"/>
                <a:ext cx="1334125" cy="5847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/>
                  <a:t>Randomization</a:t>
                </a:r>
              </a:p>
              <a:p>
                <a:pPr algn="ctr"/>
                <a:r>
                  <a:rPr lang="en-US" sz="1000"/>
                  <a:t>n=119</a:t>
                </a:r>
              </a:p>
            </p:txBody>
          </p:sp>
        </p:grpSp>
      </p:grpSp>
      <p:grpSp>
        <p:nvGrpSpPr>
          <p:cNvPr id="39" name="Group 38"/>
          <p:cNvGrpSpPr/>
          <p:nvPr/>
        </p:nvGrpSpPr>
        <p:grpSpPr>
          <a:xfrm>
            <a:off x="1109344" y="2283313"/>
            <a:ext cx="4554543" cy="172981"/>
            <a:chOff x="2608370" y="2425410"/>
            <a:chExt cx="8096966" cy="307522"/>
          </a:xfrm>
        </p:grpSpPr>
        <p:cxnSp>
          <p:nvCxnSpPr>
            <p:cNvPr id="25" name="Straight Connector 24"/>
            <p:cNvCxnSpPr>
              <a:cxnSpLocks/>
            </p:cNvCxnSpPr>
            <p:nvPr/>
          </p:nvCxnSpPr>
          <p:spPr>
            <a:xfrm>
              <a:off x="2612605" y="2425410"/>
              <a:ext cx="8092731" cy="3320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2608370" y="2425410"/>
              <a:ext cx="0" cy="27432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5231381" y="2425410"/>
              <a:ext cx="0" cy="27432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>
              <a:off x="7731693" y="2458612"/>
              <a:ext cx="0" cy="27432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>
              <a:cxnSpLocks/>
            </p:cNvCxnSpPr>
            <p:nvPr/>
          </p:nvCxnSpPr>
          <p:spPr>
            <a:xfrm>
              <a:off x="10705336" y="2458612"/>
              <a:ext cx="0" cy="27432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3270605" y="1311840"/>
            <a:ext cx="1863364" cy="400110"/>
            <a:chOff x="6486745" y="823840"/>
            <a:chExt cx="2544505" cy="407694"/>
          </a:xfrm>
        </p:grpSpPr>
        <p:cxnSp>
          <p:nvCxnSpPr>
            <p:cNvPr id="41" name="Straight Arrow Connector 40"/>
            <p:cNvCxnSpPr/>
            <p:nvPr/>
          </p:nvCxnSpPr>
          <p:spPr>
            <a:xfrm flipH="1" flipV="1">
              <a:off x="6486745" y="927552"/>
              <a:ext cx="692630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7556056" y="823840"/>
              <a:ext cx="1475194" cy="407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/>
                <a:t>Screen failures</a:t>
              </a:r>
            </a:p>
            <a:p>
              <a:pPr algn="ctr"/>
              <a:r>
                <a:rPr lang="en-US" sz="1000"/>
                <a:t>n=77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55338" y="2490919"/>
            <a:ext cx="1455796" cy="903620"/>
            <a:chOff x="1379894" y="2384770"/>
            <a:chExt cx="2588081" cy="1606436"/>
          </a:xfrm>
        </p:grpSpPr>
        <p:grpSp>
          <p:nvGrpSpPr>
            <p:cNvPr id="21" name="Group 20"/>
            <p:cNvGrpSpPr/>
            <p:nvPr/>
          </p:nvGrpSpPr>
          <p:grpSpPr>
            <a:xfrm>
              <a:off x="1379894" y="2384770"/>
              <a:ext cx="2588081" cy="1068266"/>
              <a:chOff x="4258823" y="1034320"/>
              <a:chExt cx="2146793" cy="1461145"/>
            </a:xfrm>
          </p:grpSpPr>
          <p:sp>
            <p:nvSpPr>
              <p:cNvPr id="22" name="Rectangle 21"/>
              <p:cNvSpPr/>
              <p:nvPr/>
            </p:nvSpPr>
            <p:spPr>
              <a:xfrm>
                <a:off x="4258823" y="1034320"/>
                <a:ext cx="2110720" cy="146114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75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264760" y="1041763"/>
                <a:ext cx="2140856" cy="14219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/>
                  <a:t>PQ Grass Conventional (n=41)</a:t>
                </a:r>
              </a:p>
              <a:p>
                <a:pPr algn="ctr"/>
                <a:endParaRPr lang="en-US" sz="800"/>
              </a:p>
              <a:p>
                <a:pPr algn="ctr"/>
                <a:r>
                  <a:rPr lang="en-US" sz="800"/>
                  <a:t>Mechanistic biomarker</a:t>
                </a:r>
              </a:p>
              <a:p>
                <a:pPr algn="ctr"/>
                <a:r>
                  <a:rPr lang="en-US" sz="800"/>
                  <a:t> sub-study (n=10)</a:t>
                </a:r>
              </a:p>
            </p:txBody>
          </p:sp>
        </p:grpSp>
        <p:cxnSp>
          <p:nvCxnSpPr>
            <p:cNvPr id="45" name="Straight Arrow Connector 44"/>
            <p:cNvCxnSpPr>
              <a:cxnSpLocks/>
            </p:cNvCxnSpPr>
            <p:nvPr/>
          </p:nvCxnSpPr>
          <p:spPr>
            <a:xfrm flipH="1">
              <a:off x="2720347" y="3544644"/>
              <a:ext cx="7157" cy="446562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" name="TextBox 12"/>
          <p:cNvSpPr txBox="1"/>
          <p:nvPr/>
        </p:nvSpPr>
        <p:spPr>
          <a:xfrm>
            <a:off x="468056" y="3433499"/>
            <a:ext cx="12705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/>
              <a:t>Discontinued the study, n=4 (9.8%)</a:t>
            </a:r>
          </a:p>
          <a:p>
            <a:r>
              <a:rPr lang="en-US" sz="800"/>
              <a:t> </a:t>
            </a:r>
          </a:p>
          <a:p>
            <a:pPr marL="96441" indent="-96441">
              <a:buFont typeface="Arial" panose="020B0604020202020204" pitchFamily="34" charset="0"/>
              <a:buChar char="•"/>
            </a:pPr>
            <a:r>
              <a:rPr lang="en-US" sz="800"/>
              <a:t>Major non-compliance with the        Protocol, n=1 (2.4%)</a:t>
            </a:r>
          </a:p>
          <a:p>
            <a:pPr marL="96441" indent="-96441">
              <a:buFont typeface="Arial" panose="020B0604020202020204" pitchFamily="34" charset="0"/>
              <a:buChar char="•"/>
            </a:pPr>
            <a:r>
              <a:rPr lang="en-US" sz="800"/>
              <a:t>Pregnancy, n=1 (2.4%)</a:t>
            </a:r>
          </a:p>
          <a:p>
            <a:pPr marL="96441" indent="-96441">
              <a:buFont typeface="Arial" panose="020B0604020202020204" pitchFamily="34" charset="0"/>
              <a:buChar char="•"/>
            </a:pPr>
            <a:r>
              <a:rPr lang="en-US" sz="800"/>
              <a:t>Withdrawal of consent, n=2 (4.9%)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917828" y="3453776"/>
            <a:ext cx="12705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/>
              <a:t>Discontinued the study, n=1 (2.5%) </a:t>
            </a:r>
          </a:p>
          <a:p>
            <a:pPr marL="63401" indent="-63401"/>
            <a:r>
              <a:rPr lang="en-US" sz="800"/>
              <a:t>   </a:t>
            </a:r>
          </a:p>
          <a:p>
            <a:pPr marL="96441" indent="-96441">
              <a:buFont typeface="Arial" panose="020B0604020202020204" pitchFamily="34" charset="0"/>
              <a:buChar char="•"/>
            </a:pPr>
            <a:r>
              <a:rPr lang="en-US" sz="800"/>
              <a:t>Investigator, medical monitor and/or Sponsor decision, n=1 (2.5%)</a:t>
            </a:r>
          </a:p>
          <a:p>
            <a:r>
              <a:rPr lang="en-US" sz="800"/>
              <a:t>  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212BB5B-C23D-A024-D772-124B8C71B267}"/>
              </a:ext>
            </a:extLst>
          </p:cNvPr>
          <p:cNvCxnSpPr/>
          <p:nvPr/>
        </p:nvCxnSpPr>
        <p:spPr>
          <a:xfrm>
            <a:off x="1109344" y="2677433"/>
            <a:ext cx="0" cy="10287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F4FBBA50-254C-57D8-93F5-A6AFE62FA05E}"/>
              </a:ext>
            </a:extLst>
          </p:cNvPr>
          <p:cNvSpPr txBox="1"/>
          <p:nvPr/>
        </p:nvSpPr>
        <p:spPr>
          <a:xfrm>
            <a:off x="1884009" y="2484683"/>
            <a:ext cx="133823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/>
              <a:t>PQ Grass Extended (n=40)</a:t>
            </a:r>
          </a:p>
          <a:p>
            <a:pPr algn="ctr"/>
            <a:endParaRPr lang="en-US" sz="800"/>
          </a:p>
          <a:p>
            <a:pPr algn="ctr"/>
            <a:r>
              <a:rPr lang="en-US" sz="800"/>
              <a:t>Mechanistic biomarker sub-study (n=10)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3DE5992-0B92-A7E0-8E73-65C0206248E8}"/>
              </a:ext>
            </a:extLst>
          </p:cNvPr>
          <p:cNvSpPr/>
          <p:nvPr/>
        </p:nvSpPr>
        <p:spPr>
          <a:xfrm>
            <a:off x="1896088" y="2485579"/>
            <a:ext cx="1314081" cy="6009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75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DB2C650-E4CE-ED7C-81B4-634F992C4989}"/>
              </a:ext>
            </a:extLst>
          </p:cNvPr>
          <p:cNvSpPr/>
          <p:nvPr/>
        </p:nvSpPr>
        <p:spPr>
          <a:xfrm>
            <a:off x="3355914" y="2474969"/>
            <a:ext cx="1350414" cy="6115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75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4DCD584-6F99-A4FE-581F-566D8402B1D7}"/>
              </a:ext>
            </a:extLst>
          </p:cNvPr>
          <p:cNvSpPr txBox="1"/>
          <p:nvPr/>
        </p:nvSpPr>
        <p:spPr>
          <a:xfrm>
            <a:off x="3376044" y="2493641"/>
            <a:ext cx="13504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/>
              <a:t>Placebo with MCT (n=20)</a:t>
            </a:r>
          </a:p>
          <a:p>
            <a:pPr algn="ctr"/>
            <a:endParaRPr lang="en-US" sz="800"/>
          </a:p>
          <a:p>
            <a:pPr algn="ctr"/>
            <a:r>
              <a:rPr lang="en-US" sz="800"/>
              <a:t>Mechanistic biomarker sub-study (n=5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0F74E77-BB52-D8B8-D94D-D6E1F4D81255}"/>
              </a:ext>
            </a:extLst>
          </p:cNvPr>
          <p:cNvSpPr txBox="1"/>
          <p:nvPr/>
        </p:nvSpPr>
        <p:spPr>
          <a:xfrm>
            <a:off x="4925153" y="2463410"/>
            <a:ext cx="141244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/>
              <a:t>Placebo (n=18)</a:t>
            </a:r>
          </a:p>
          <a:p>
            <a:pPr algn="ctr"/>
            <a:endParaRPr lang="en-US" sz="800"/>
          </a:p>
          <a:p>
            <a:pPr algn="ctr"/>
            <a:r>
              <a:rPr lang="en-US" sz="800"/>
              <a:t>Mechanistic biomarker sub-study (n=5)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55733FBE-2ECF-23F7-D9E6-A3EE38020474}"/>
              </a:ext>
            </a:extLst>
          </p:cNvPr>
          <p:cNvSpPr/>
          <p:nvPr/>
        </p:nvSpPr>
        <p:spPr>
          <a:xfrm>
            <a:off x="4925153" y="2474969"/>
            <a:ext cx="1416468" cy="60344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75"/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2C718D2C-6D29-74CE-33F4-87BCC4E92FA3}"/>
              </a:ext>
            </a:extLst>
          </p:cNvPr>
          <p:cNvCxnSpPr/>
          <p:nvPr/>
        </p:nvCxnSpPr>
        <p:spPr>
          <a:xfrm>
            <a:off x="2584788" y="2677433"/>
            <a:ext cx="0" cy="10287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9EE88456-26BB-6E43-96FD-E3C3506F37B1}"/>
              </a:ext>
            </a:extLst>
          </p:cNvPr>
          <p:cNvCxnSpPr/>
          <p:nvPr/>
        </p:nvCxnSpPr>
        <p:spPr>
          <a:xfrm>
            <a:off x="4029138" y="2677433"/>
            <a:ext cx="0" cy="10287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8F3C78BE-73E5-A26B-DD9E-AB68C1693CAE}"/>
              </a:ext>
            </a:extLst>
          </p:cNvPr>
          <p:cNvCxnSpPr>
            <a:cxnSpLocks/>
          </p:cNvCxnSpPr>
          <p:nvPr/>
        </p:nvCxnSpPr>
        <p:spPr>
          <a:xfrm>
            <a:off x="5663887" y="2677433"/>
            <a:ext cx="0" cy="10287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633B044D-B833-D797-2B21-23D5D5413CD4}"/>
              </a:ext>
            </a:extLst>
          </p:cNvPr>
          <p:cNvSpPr/>
          <p:nvPr/>
        </p:nvSpPr>
        <p:spPr>
          <a:xfrm>
            <a:off x="355338" y="3442489"/>
            <a:ext cx="1415232" cy="119133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75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16D15DC6-BADC-11C4-14B0-040781204191}"/>
              </a:ext>
            </a:extLst>
          </p:cNvPr>
          <p:cNvSpPr/>
          <p:nvPr/>
        </p:nvSpPr>
        <p:spPr>
          <a:xfrm>
            <a:off x="1939570" y="3443619"/>
            <a:ext cx="1270599" cy="119133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75"/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33AADC3A-BC27-428D-47A2-5F3C0F088D09}"/>
              </a:ext>
            </a:extLst>
          </p:cNvPr>
          <p:cNvCxnSpPr>
            <a:cxnSpLocks/>
          </p:cNvCxnSpPr>
          <p:nvPr/>
        </p:nvCxnSpPr>
        <p:spPr>
          <a:xfrm flipH="1">
            <a:off x="2584788" y="3127964"/>
            <a:ext cx="4026" cy="25119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Rectangle 79">
            <a:extLst>
              <a:ext uri="{FF2B5EF4-FFF2-40B4-BE49-F238E27FC236}">
                <a16:creationId xmlns:a16="http://schemas.microsoft.com/office/drawing/2014/main" id="{50CD2D44-0FB9-C85C-5BCD-686E23A68D47}"/>
              </a:ext>
            </a:extLst>
          </p:cNvPr>
          <p:cNvSpPr/>
          <p:nvPr/>
        </p:nvSpPr>
        <p:spPr>
          <a:xfrm>
            <a:off x="3959676" y="1296050"/>
            <a:ext cx="1333671" cy="3835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75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CB50566-1E75-1310-8A7C-59183F27106F}"/>
              </a:ext>
            </a:extLst>
          </p:cNvPr>
          <p:cNvSpPr txBox="1"/>
          <p:nvPr/>
        </p:nvSpPr>
        <p:spPr>
          <a:xfrm>
            <a:off x="6126" y="9536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E1</a:t>
            </a:r>
            <a:endParaRPr lang="en-US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3174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AE52512272D44BB074101A15BF15E9" ma:contentTypeVersion="16" ma:contentTypeDescription="Create a new document." ma:contentTypeScope="" ma:versionID="7bc4ed5e1bf1c330d545856942c2ea87">
  <xsd:schema xmlns:xsd="http://www.w3.org/2001/XMLSchema" xmlns:xs="http://www.w3.org/2001/XMLSchema" xmlns:p="http://schemas.microsoft.com/office/2006/metadata/properties" xmlns:ns2="dddeb55e-3631-4795-802d-e3c70af94a98" xmlns:ns3="eb07c517-3670-477e-a221-b145e09753ca" targetNamespace="http://schemas.microsoft.com/office/2006/metadata/properties" ma:root="true" ma:fieldsID="e134757dc0b3567c9dfb2bd7333da9d0" ns2:_="" ns3:_="">
    <xsd:import namespace="dddeb55e-3631-4795-802d-e3c70af94a98"/>
    <xsd:import namespace="eb07c517-3670-477e-a221-b145e09753c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ReviewFlow" minOccurs="0"/>
                <xsd:element ref="ns2:ApprovalFlow" minOccurs="0"/>
                <xsd:element ref="ns2:WFInitiator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ddeb55e-3631-4795-802d-e3c70af94a9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ReviewFlow" ma:index="12" nillable="true" ma:displayName="ReviewFlow" ma:internalName="ReviewFlow">
      <xsd:simpleType>
        <xsd:restriction base="dms:Choice">
          <xsd:enumeration value="Not Started"/>
          <xsd:enumeration value="In Progress"/>
          <xsd:enumeration value="Reviewed"/>
        </xsd:restriction>
      </xsd:simpleType>
    </xsd:element>
    <xsd:element name="ApprovalFlow" ma:index="13" nillable="true" ma:displayName="ApprovalFlow" ma:internalName="ApprovalFlow">
      <xsd:simpleType>
        <xsd:restriction base="dms:Choice">
          <xsd:enumeration value="Not Started"/>
          <xsd:enumeration value="In Progress"/>
          <xsd:enumeration value="Approved"/>
        </xsd:restriction>
      </xsd:simpleType>
    </xsd:element>
    <xsd:element name="WFInitiator" ma:index="14" nillable="true" ma:displayName="WFInitiator" ma:internalName="WFInitiator">
      <xsd:simpleType>
        <xsd:restriction base="dms:Text"/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a306c6d1-e6a6-429d-9fde-c8374a10a63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3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b07c517-3670-477e-a221-b145e09753ca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5f00fec2-6b66-4ca0-83db-1356f88b302c}" ma:internalName="TaxCatchAll" ma:showField="CatchAllData" ma:web="eb07c517-3670-477e-a221-b145e09753c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WFInitiator xmlns="dddeb55e-3631-4795-802d-e3c70af94a98">Sviatlana Starchenka</WFInitiator>
    <ApprovalFlow xmlns="dddeb55e-3631-4795-802d-e3c70af94a98" xsi:nil="true"/>
    <ReviewFlow xmlns="dddeb55e-3631-4795-802d-e3c70af94a98">Reviewed</ReviewFlow>
    <lcf76f155ced4ddcb4097134ff3c332f xmlns="dddeb55e-3631-4795-802d-e3c70af94a98">
      <Terms xmlns="http://schemas.microsoft.com/office/infopath/2007/PartnerControls"/>
    </lcf76f155ced4ddcb4097134ff3c332f>
    <TaxCatchAll xmlns="eb07c517-3670-477e-a221-b145e09753ca" xsi:nil="true"/>
  </documentManagement>
</p:properties>
</file>

<file path=customXml/itemProps1.xml><?xml version="1.0" encoding="utf-8"?>
<ds:datastoreItem xmlns:ds="http://schemas.openxmlformats.org/officeDocument/2006/customXml" ds:itemID="{2FBE8BE0-5A87-4DB2-A200-8F8EF6BC7E5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ddeb55e-3631-4795-802d-e3c70af94a98"/>
    <ds:schemaRef ds:uri="eb07c517-3670-477e-a221-b145e09753c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6ADC2D3-660F-414D-B034-C5F16644DE2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EF07CE5-31E1-4928-91ED-572946AB7720}">
  <ds:schemaRefs>
    <ds:schemaRef ds:uri="dddeb55e-3631-4795-802d-e3c70af94a98"/>
    <ds:schemaRef ds:uri="http://schemas.microsoft.com/office/2006/metadata/properties"/>
    <ds:schemaRef ds:uri="http://purl.org/dc/terms/"/>
    <ds:schemaRef ds:uri="http://www.w3.org/XML/1998/namespace"/>
    <ds:schemaRef ds:uri="http://purl.org/dc/dcmitype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eb07c517-3670-477e-a221-b145e09753c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829</TotalTime>
  <Words>147</Words>
  <Application>Microsoft Macintosh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yhadi, Janice A</dc:creator>
  <cp:lastModifiedBy>Layhadi, Janice A</cp:lastModifiedBy>
  <cp:revision>15</cp:revision>
  <dcterms:created xsi:type="dcterms:W3CDTF">2024-01-07T19:08:07Z</dcterms:created>
  <dcterms:modified xsi:type="dcterms:W3CDTF">2024-08-22T13:41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AE52512272D44BB074101A15BF15E9</vt:lpwstr>
  </property>
  <property fmtid="{D5CDD505-2E9C-101B-9397-08002B2CF9AE}" pid="3" name="MediaServiceImageTags">
    <vt:lpwstr/>
  </property>
</Properties>
</file>